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9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9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338" y="-216"/>
      </p:cViewPr>
      <p:guideLst>
        <p:guide orient="horz" pos="1927"/>
        <p:guide pos="9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fpuadmin\Desktop\NHDF&#35542;&#25991;&#20316;&#25104;\Data%20for%20paper%20puerarin%20(&#22238;&#24489;&#28168;&#12415;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CK8 senescence'!$L$79:$N$79</c:f>
                <c:numCache>
                  <c:formatCode>General</c:formatCode>
                  <c:ptCount val="3"/>
                  <c:pt idx="0">
                    <c:v>52.930123061009631</c:v>
                  </c:pt>
                  <c:pt idx="1">
                    <c:v>37.773024844077803</c:v>
                  </c:pt>
                  <c:pt idx="2">
                    <c:v>47.088265330325356</c:v>
                  </c:pt>
                </c:numCache>
              </c:numRef>
            </c:plus>
            <c:minus>
              <c:numRef>
                <c:f>'CCK8 senescence'!$L$79:$N$79</c:f>
                <c:numCache>
                  <c:formatCode>General</c:formatCode>
                  <c:ptCount val="3"/>
                  <c:pt idx="0">
                    <c:v>52.930123061009631</c:v>
                  </c:pt>
                  <c:pt idx="1">
                    <c:v>37.773024844077803</c:v>
                  </c:pt>
                  <c:pt idx="2">
                    <c:v>47.088265330325356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CCK8 senescence'!$L$40:$N$40</c:f>
              <c:strCache>
                <c:ptCount val="3"/>
                <c:pt idx="0">
                  <c:v>-</c:v>
                </c:pt>
                <c:pt idx="1">
                  <c:v>25</c:v>
                </c:pt>
                <c:pt idx="2">
                  <c:v>50</c:v>
                </c:pt>
              </c:strCache>
            </c:strRef>
          </c:cat>
          <c:val>
            <c:numRef>
              <c:f>'CCK8 senescence'!$L$78:$N$78</c:f>
              <c:numCache>
                <c:formatCode>General</c:formatCode>
                <c:ptCount val="3"/>
                <c:pt idx="0">
                  <c:v>100</c:v>
                </c:pt>
                <c:pt idx="1">
                  <c:v>119.40839118623607</c:v>
                </c:pt>
                <c:pt idx="2">
                  <c:v>84.002414729852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BF-47BA-9B31-1317E93BF8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308641000"/>
        <c:axId val="308639824"/>
      </c:barChart>
      <c:catAx>
        <c:axId val="308641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8639824"/>
        <c:crosses val="autoZero"/>
        <c:auto val="1"/>
        <c:lblAlgn val="ctr"/>
        <c:lblOffset val="100"/>
        <c:noMultiLvlLbl val="0"/>
      </c:catAx>
      <c:valAx>
        <c:axId val="308639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8641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38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49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53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6227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09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766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995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84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6205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1863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491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3BF8-DA32-4E23-A87A-576B88BD6248}" type="datetimeFigureOut">
              <a:rPr kumimoji="1" lang="ja-JP" altLang="en-US" smtClean="0"/>
              <a:t>2021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86F56C-42E2-4086-AF15-67DFB422B96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756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59657" y="420914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1 Fig.</a:t>
            </a:r>
            <a:endParaRPr kumimoji="1" lang="ja-JP" altLang="en-US" b="1" dirty="0"/>
          </a:p>
        </p:txBody>
      </p:sp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11614333"/>
              </p:ext>
            </p:extLst>
          </p:nvPr>
        </p:nvGraphicFramePr>
        <p:xfrm>
          <a:off x="1793741" y="790246"/>
          <a:ext cx="2472639" cy="29000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正方形/長方形 1"/>
          <p:cNvSpPr/>
          <p:nvPr/>
        </p:nvSpPr>
        <p:spPr>
          <a:xfrm>
            <a:off x="955068" y="3973009"/>
            <a:ext cx="4893129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/>
              <a:t>S1 Fig. </a:t>
            </a:r>
            <a:r>
              <a:rPr lang="en-US" altLang="ja-JP" sz="1600" dirty="0"/>
              <a:t>The effect of puerarin on cell toxicity in low-passage NHDFs.</a:t>
            </a:r>
            <a:endParaRPr lang="ja-JP" altLang="ja-JP" sz="1600" dirty="0"/>
          </a:p>
          <a:p>
            <a:r>
              <a:rPr lang="en-US" altLang="ja-JP" sz="1600" dirty="0"/>
              <a:t>The effect of cellular LDH release in low passage NHDFs.  Data was obtained from LDH assay. n=6.  </a:t>
            </a:r>
            <a:endParaRPr lang="ja-JP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061053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51</TotalTime>
  <Words>39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Presentation</vt:lpstr>
    </vt:vector>
  </TitlesOfParts>
  <Company>福井県立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井県立大学</dc:creator>
  <cp:lastModifiedBy>chn off28</cp:lastModifiedBy>
  <cp:revision>131</cp:revision>
  <cp:lastPrinted>2020-03-25T12:54:27Z</cp:lastPrinted>
  <dcterms:created xsi:type="dcterms:W3CDTF">2020-02-05T00:21:06Z</dcterms:created>
  <dcterms:modified xsi:type="dcterms:W3CDTF">2021-04-16T05:45:36Z</dcterms:modified>
</cp:coreProperties>
</file>